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tiff" ContentType="image/tiff"/>
  <Default Extension="emf" ContentType="image/x-emf"/>
  <Default Extension="xlsx" ContentType="application/vnd.openxmlformats-officedocument.spreadsheetml.sheet"/>
  <Default Extension="rels" ContentType="application/vnd.openxmlformats-package.relationships+xml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66" r:id="rId3"/>
    <p:sldId id="257" r:id="rId4"/>
    <p:sldId id="258" r:id="rId5"/>
    <p:sldId id="273" r:id="rId6"/>
    <p:sldId id="260" r:id="rId7"/>
    <p:sldId id="272" r:id="rId8"/>
    <p:sldId id="265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668"/>
  </p:normalViewPr>
  <p:slideViewPr>
    <p:cSldViewPr>
      <p:cViewPr>
        <p:scale>
          <a:sx n="84" d="100"/>
          <a:sy n="84" d="100"/>
        </p:scale>
        <p:origin x="2464" y="4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77312554680665"/>
          <c:y val="0.0277777777777778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VID cluster LacZ+41BB vs untr'!$P$1</c:f>
              <c:strCache>
                <c:ptCount val="1"/>
                <c:pt idx="0">
                  <c:v>Enrichment score</c:v>
                </c:pt>
              </c:strCache>
            </c:strRef>
          </c:tx>
          <c:invertIfNegative val="0"/>
          <c:cat>
            <c:strRef>
              <c:f>'DAVID cluster LacZ+41BB vs untr'!$O$2:$O$11</c:f>
              <c:strCache>
                <c:ptCount val="10"/>
                <c:pt idx="0">
                  <c:v>Cell cycle</c:v>
                </c:pt>
                <c:pt idx="1">
                  <c:v>DNA replication</c:v>
                </c:pt>
                <c:pt idx="2">
                  <c:v>DNA damage</c:v>
                </c:pt>
                <c:pt idx="3">
                  <c:v>Microtubule</c:v>
                </c:pt>
                <c:pt idx="4">
                  <c:v>Nucleotide-binding</c:v>
                </c:pt>
                <c:pt idx="5">
                  <c:v>Cytokine</c:v>
                </c:pt>
                <c:pt idx="6">
                  <c:v>Innate immunity</c:v>
                </c:pt>
                <c:pt idx="7">
                  <c:v>Antiviral defense</c:v>
                </c:pt>
                <c:pt idx="8">
                  <c:v>kinesin complex</c:v>
                </c:pt>
                <c:pt idx="9">
                  <c:v>DNA replication initiation</c:v>
                </c:pt>
              </c:strCache>
            </c:strRef>
          </c:cat>
          <c:val>
            <c:numRef>
              <c:f>'DAVID cluster LacZ+41BB vs untr'!$P$2:$P$11</c:f>
              <c:numCache>
                <c:formatCode>General</c:formatCode>
                <c:ptCount val="10"/>
                <c:pt idx="0">
                  <c:v>31.6132561102063</c:v>
                </c:pt>
                <c:pt idx="1">
                  <c:v>16.0242589500051</c:v>
                </c:pt>
                <c:pt idx="2">
                  <c:v>10.8688580604705</c:v>
                </c:pt>
                <c:pt idx="3">
                  <c:v>8.779141209234168</c:v>
                </c:pt>
                <c:pt idx="4">
                  <c:v>7.614920558809</c:v>
                </c:pt>
                <c:pt idx="5">
                  <c:v>6.040872007638495</c:v>
                </c:pt>
                <c:pt idx="6">
                  <c:v>6.02167189151969</c:v>
                </c:pt>
                <c:pt idx="7">
                  <c:v>5.68389940147804</c:v>
                </c:pt>
                <c:pt idx="8">
                  <c:v>4.77546592900992</c:v>
                </c:pt>
                <c:pt idx="9">
                  <c:v>4.6022859257275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803061936"/>
        <c:axId val="-1803059616"/>
      </c:barChart>
      <c:catAx>
        <c:axId val="-1803061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803059616"/>
        <c:crosses val="autoZero"/>
        <c:auto val="1"/>
        <c:lblAlgn val="ctr"/>
        <c:lblOffset val="100"/>
        <c:noMultiLvlLbl val="0"/>
      </c:catAx>
      <c:valAx>
        <c:axId val="-18030596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180306193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3018322038292"/>
          <c:y val="0.092383915014733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0623975348704841"/>
          <c:y val="0.172893024853671"/>
          <c:w val="0.70716449385592"/>
          <c:h val="0.5314877645981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Enrichment score</c:v>
                </c:pt>
              </c:strCache>
            </c:strRef>
          </c:tx>
          <c:invertIfNegative val="0"/>
          <c:cat>
            <c:strRef>
              <c:f>Sheet1!$A$2:$A$8</c:f>
              <c:strCache>
                <c:ptCount val="7"/>
                <c:pt idx="0">
                  <c:v>Cell cycle</c:v>
                </c:pt>
                <c:pt idx="1">
                  <c:v>DNA repair</c:v>
                </c:pt>
                <c:pt idx="2">
                  <c:v>ATP-binding</c:v>
                </c:pt>
                <c:pt idx="3">
                  <c:v>Cytoskeleton</c:v>
                </c:pt>
                <c:pt idx="4">
                  <c:v>Antiviral defense</c:v>
                </c:pt>
                <c:pt idx="5">
                  <c:v>p53 signaling pathway</c:v>
                </c:pt>
                <c:pt idx="6">
                  <c:v>Cytokine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31.7598434909465</c:v>
                </c:pt>
                <c:pt idx="1">
                  <c:v>8.902578083910818</c:v>
                </c:pt>
                <c:pt idx="2">
                  <c:v>7.648164922755404</c:v>
                </c:pt>
                <c:pt idx="3">
                  <c:v>7.29091170497827</c:v>
                </c:pt>
                <c:pt idx="4">
                  <c:v>2.46214983786037</c:v>
                </c:pt>
                <c:pt idx="5">
                  <c:v>2.36061875874549</c:v>
                </c:pt>
                <c:pt idx="6">
                  <c:v>1.797023322832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830874800"/>
        <c:axId val="-1830872752"/>
      </c:barChart>
      <c:catAx>
        <c:axId val="-1830874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830872752"/>
        <c:crosses val="autoZero"/>
        <c:auto val="1"/>
        <c:lblAlgn val="ctr"/>
        <c:lblOffset val="100"/>
        <c:noMultiLvlLbl val="0"/>
      </c:catAx>
      <c:valAx>
        <c:axId val="-18308727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1830874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79923245198452"/>
          <c:y val="0.0699867466042848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VID cluster LacZ+41BB vs LacZ'!$P$1</c:f>
              <c:strCache>
                <c:ptCount val="1"/>
                <c:pt idx="0">
                  <c:v>Enrichment score</c:v>
                </c:pt>
              </c:strCache>
            </c:strRef>
          </c:tx>
          <c:invertIfNegative val="0"/>
          <c:cat>
            <c:strRef>
              <c:f>'DAVID cluster LacZ+41BB vs LacZ'!$O$2:$O$9</c:f>
              <c:strCache>
                <c:ptCount val="8"/>
                <c:pt idx="0">
                  <c:v>Cell cycle</c:v>
                </c:pt>
                <c:pt idx="1">
                  <c:v>Cytoskeleton</c:v>
                </c:pt>
                <c:pt idx="2">
                  <c:v>Microtubule</c:v>
                </c:pt>
                <c:pt idx="3">
                  <c:v>Secreted</c:v>
                </c:pt>
                <c:pt idx="4">
                  <c:v>Nucleotide-binding</c:v>
                </c:pt>
                <c:pt idx="5">
                  <c:v>ECM-receptor interaction</c:v>
                </c:pt>
                <c:pt idx="6">
                  <c:v>Serpin family</c:v>
                </c:pt>
                <c:pt idx="7">
                  <c:v>Cytokine and chemokine</c:v>
                </c:pt>
              </c:strCache>
            </c:strRef>
          </c:cat>
          <c:val>
            <c:numRef>
              <c:f>'DAVID cluster LacZ+41BB vs LacZ'!$P$2:$P$9</c:f>
              <c:numCache>
                <c:formatCode>General</c:formatCode>
                <c:ptCount val="8"/>
                <c:pt idx="0">
                  <c:v>17.1039009072748</c:v>
                </c:pt>
                <c:pt idx="1">
                  <c:v>9.18186458411928</c:v>
                </c:pt>
                <c:pt idx="2">
                  <c:v>6.40314123704312</c:v>
                </c:pt>
                <c:pt idx="3">
                  <c:v>4.23657441344659</c:v>
                </c:pt>
                <c:pt idx="4">
                  <c:v>3.0044364836157</c:v>
                </c:pt>
                <c:pt idx="5">
                  <c:v>2.837143399123262</c:v>
                </c:pt>
                <c:pt idx="6">
                  <c:v>2.75803995645226</c:v>
                </c:pt>
                <c:pt idx="7">
                  <c:v>2.6770962449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861389008"/>
        <c:axId val="-1861596848"/>
      </c:barChart>
      <c:catAx>
        <c:axId val="-1861389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861596848"/>
        <c:crosses val="autoZero"/>
        <c:auto val="1"/>
        <c:lblAlgn val="ctr"/>
        <c:lblOffset val="100"/>
        <c:noMultiLvlLbl val="0"/>
      </c:catAx>
      <c:valAx>
        <c:axId val="-18615968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18613890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DFC1F-DC1E-4909-A00B-CD181EBB5BFD}" type="datetimeFigureOut">
              <a:rPr lang="en-US" smtClean="0"/>
              <a:t>5/1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2994B7-E8CF-4E53-8ADE-6B6D0B5AC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581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E3F9D4-E097-A740-B24C-5B464F399AF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7402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2994B7-E8CF-4E53-8ADE-6B6D0B5ACFB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1171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2994B7-E8CF-4E53-8ADE-6B6D0B5ACFB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51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431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366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58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431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629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69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420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376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734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479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98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2454B-447A-4EA1-BA6D-51D6C2FEFD90}" type="datetimeFigureOut">
              <a:rPr lang="en-US" smtClean="0"/>
              <a:t>5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83393-BEB2-4560-BAD3-4B439605E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098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tiff"/><Relationship Id="rId13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image" Target="../media/image14.jpg"/><Relationship Id="rId5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4" Type="http://schemas.openxmlformats.org/officeDocument/2006/relationships/image" Target="../media/image17.emf"/><Relationship Id="rId5" Type="http://schemas.openxmlformats.org/officeDocument/2006/relationships/image" Target="../media/image18.emf"/><Relationship Id="rId6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4" Type="http://schemas.openxmlformats.org/officeDocument/2006/relationships/image" Target="../media/image22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4" Type="http://schemas.openxmlformats.org/officeDocument/2006/relationships/image" Target="../media/image25.emf"/><Relationship Id="rId5" Type="http://schemas.openxmlformats.org/officeDocument/2006/relationships/image" Target="../media/image26.emf"/><Relationship Id="rId6" Type="http://schemas.openxmlformats.org/officeDocument/2006/relationships/image" Target="../media/image27.emf"/><Relationship Id="rId7" Type="http://schemas.openxmlformats.org/officeDocument/2006/relationships/image" Target="../media/image28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emf"/></Relationships>
</file>

<file path=ppt/slides/_rels/slide8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8.tiff"/><Relationship Id="rId12" Type="http://schemas.openxmlformats.org/officeDocument/2006/relationships/image" Target="../media/image39.emf"/><Relationship Id="rId13" Type="http://schemas.openxmlformats.org/officeDocument/2006/relationships/image" Target="../media/image40.emf"/><Relationship Id="rId14" Type="http://schemas.openxmlformats.org/officeDocument/2006/relationships/image" Target="../media/image41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PNG"/><Relationship Id="rId3" Type="http://schemas.openxmlformats.org/officeDocument/2006/relationships/image" Target="../media/image30.tiff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tiff"/><Relationship Id="rId10" Type="http://schemas.openxmlformats.org/officeDocument/2006/relationships/image" Target="../media/image3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9874" y="337252"/>
            <a:ext cx="5943624" cy="1760607"/>
            <a:chOff x="217485" y="8077904"/>
            <a:chExt cx="5943624" cy="1760607"/>
          </a:xfrm>
        </p:grpSpPr>
        <p:grpSp>
          <p:nvGrpSpPr>
            <p:cNvPr id="5" name="Group 4"/>
            <p:cNvGrpSpPr/>
            <p:nvPr/>
          </p:nvGrpSpPr>
          <p:grpSpPr>
            <a:xfrm>
              <a:off x="217485" y="8337376"/>
              <a:ext cx="5943624" cy="1501135"/>
              <a:chOff x="217485" y="8337376"/>
              <a:chExt cx="5943624" cy="1501135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45888" y="8337376"/>
                <a:ext cx="1350000" cy="1080000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485" y="833737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11109" y="8337376"/>
                <a:ext cx="1350000" cy="1080000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89548" y="8337376"/>
                <a:ext cx="1440000" cy="1080000"/>
              </a:xfrm>
              <a:prstGeom prst="rect">
                <a:avLst/>
              </a:prstGeom>
            </p:spPr>
          </p:pic>
          <p:cxnSp>
            <p:nvCxnSpPr>
              <p:cNvPr id="14" name="Straight Connector 13"/>
              <p:cNvCxnSpPr/>
              <p:nvPr/>
            </p:nvCxnSpPr>
            <p:spPr>
              <a:xfrm>
                <a:off x="239694" y="9561512"/>
                <a:ext cx="285619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3296258" y="9550399"/>
                <a:ext cx="285619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365078" y="9561512"/>
                <a:ext cx="4315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A20</a:t>
                </a:r>
                <a:endParaRPr lang="en-US" sz="12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581128" y="9561512"/>
                <a:ext cx="444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BHK</a:t>
                </a:r>
                <a:endParaRPr lang="en-US" sz="1200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683186" y="8121352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FP</a:t>
              </a:r>
              <a:endParaRPr 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727584" y="8121352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FP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985198" y="8121352"/>
              <a:ext cx="8677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Bright field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5480" y="8077904"/>
              <a:ext cx="8677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Bright field</a:t>
              </a:r>
              <a:endParaRPr lang="en-US" sz="1200" dirty="0"/>
            </a:p>
          </p:txBody>
        </p:sp>
      </p:grp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493" y="4461549"/>
            <a:ext cx="1483717" cy="1447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6795" y="4479512"/>
            <a:ext cx="1444263" cy="14073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4" name="Straight Arrow Connector 33"/>
          <p:cNvCxnSpPr/>
          <p:nvPr/>
        </p:nvCxnSpPr>
        <p:spPr>
          <a:xfrm>
            <a:off x="808813" y="8913440"/>
            <a:ext cx="1251479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2353089" y="9068489"/>
            <a:ext cx="1251479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094306" y="8930691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D45.1</a:t>
            </a:r>
            <a:endParaRPr 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2750490" y="906848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FP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3614586" y="6473793"/>
            <a:ext cx="2375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V-GFP infected  CD45.1 m</a:t>
            </a:r>
            <a:r>
              <a:rPr lang="en-US" altLang="zh-CN" sz="1200" dirty="0" smtClean="0"/>
              <a:t>ous</a:t>
            </a:r>
            <a:r>
              <a:rPr lang="en-US" sz="1200" dirty="0" smtClean="0"/>
              <a:t>e 1 </a:t>
            </a:r>
            <a:endParaRPr lang="en-US" sz="1200" dirty="0"/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518242" y="4592960"/>
            <a:ext cx="1" cy="403244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20918" y="6066407"/>
            <a:ext cx="369332" cy="5427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D45.2</a:t>
            </a:r>
            <a:endParaRPr lang="en-US" sz="1200" dirty="0"/>
          </a:p>
        </p:txBody>
      </p:sp>
      <p:sp>
        <p:nvSpPr>
          <p:cNvPr id="55" name="TextBox 54"/>
          <p:cNvSpPr txBox="1"/>
          <p:nvPr/>
        </p:nvSpPr>
        <p:spPr>
          <a:xfrm>
            <a:off x="3614586" y="7925157"/>
            <a:ext cx="23406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V-GFP </a:t>
            </a:r>
            <a:r>
              <a:rPr lang="en-US" sz="1200" dirty="0"/>
              <a:t>infected CD45.1 </a:t>
            </a:r>
            <a:r>
              <a:rPr lang="en-US" sz="1200" dirty="0" smtClean="0"/>
              <a:t>m</a:t>
            </a:r>
            <a:r>
              <a:rPr lang="en-US" altLang="zh-CN" sz="1200" dirty="0" smtClean="0"/>
              <a:t>ous</a:t>
            </a:r>
            <a:r>
              <a:rPr lang="en-US" sz="1200" dirty="0" smtClean="0"/>
              <a:t>e </a:t>
            </a:r>
            <a:r>
              <a:rPr lang="en-US" sz="1200" dirty="0"/>
              <a:t>2 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607931" y="5036041"/>
            <a:ext cx="1848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ninfected CD45.2 m</a:t>
            </a:r>
            <a:r>
              <a:rPr lang="en-US" altLang="zh-CN" sz="1200" dirty="0" smtClean="0"/>
              <a:t>ouse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44624" y="1284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grpSp>
        <p:nvGrpSpPr>
          <p:cNvPr id="64" name="Group 63"/>
          <p:cNvGrpSpPr/>
          <p:nvPr/>
        </p:nvGrpSpPr>
        <p:grpSpPr>
          <a:xfrm>
            <a:off x="116632" y="2144688"/>
            <a:ext cx="3727287" cy="2094302"/>
            <a:chOff x="116632" y="2144688"/>
            <a:chExt cx="3727287" cy="2094302"/>
          </a:xfrm>
        </p:grpSpPr>
        <p:grpSp>
          <p:nvGrpSpPr>
            <p:cNvPr id="58" name="Group 57"/>
            <p:cNvGrpSpPr/>
            <p:nvPr/>
          </p:nvGrpSpPr>
          <p:grpSpPr>
            <a:xfrm>
              <a:off x="620688" y="2288704"/>
              <a:ext cx="3223231" cy="1950286"/>
              <a:chOff x="282083" y="2288704"/>
              <a:chExt cx="3223231" cy="1950286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82083" y="2288704"/>
                <a:ext cx="3223231" cy="1672336"/>
                <a:chOff x="568917" y="3561637"/>
                <a:chExt cx="6652197" cy="3799136"/>
              </a:xfrm>
            </p:grpSpPr>
            <p:pic>
              <p:nvPicPr>
                <p:cNvPr id="18" name="Picture 17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931814" y="4016896"/>
                  <a:ext cx="3289300" cy="3200400"/>
                </a:xfrm>
                <a:prstGeom prst="rect">
                  <a:avLst/>
                </a:prstGeom>
              </p:spPr>
            </p:pic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568917" y="4025717"/>
                  <a:ext cx="3340100" cy="3225799"/>
                </a:xfrm>
                <a:prstGeom prst="rect">
                  <a:avLst/>
                </a:prstGeom>
              </p:spPr>
            </p:pic>
            <p:cxnSp>
              <p:nvCxnSpPr>
                <p:cNvPr id="20" name="Straight Arrow Connector 19"/>
                <p:cNvCxnSpPr/>
                <p:nvPr/>
              </p:nvCxnSpPr>
              <p:spPr>
                <a:xfrm>
                  <a:off x="777318" y="7360773"/>
                  <a:ext cx="6443796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>
                  <a:off x="1181697" y="3618837"/>
                  <a:ext cx="2020166" cy="5160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BHK uninfected</a:t>
                  </a:r>
                  <a:endParaRPr lang="en-US" sz="1200" dirty="0"/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4779679" y="3561637"/>
                  <a:ext cx="1737703" cy="51602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BHK infected</a:t>
                  </a:r>
                  <a:endParaRPr lang="en-US" sz="1200" dirty="0"/>
                </a:p>
              </p:txBody>
            </p:sp>
          </p:grpSp>
          <p:sp>
            <p:nvSpPr>
              <p:cNvPr id="56" name="TextBox 55"/>
              <p:cNvSpPr txBox="1"/>
              <p:nvPr/>
            </p:nvSpPr>
            <p:spPr>
              <a:xfrm>
                <a:off x="1734371" y="3961991"/>
                <a:ext cx="4331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GFP</a:t>
                </a:r>
                <a:endParaRPr lang="en-US" sz="1200" dirty="0"/>
              </a:p>
            </p:txBody>
          </p:sp>
        </p:grpSp>
        <p:sp>
          <p:nvSpPr>
            <p:cNvPr id="63" name="TextBox 62"/>
            <p:cNvSpPr txBox="1"/>
            <p:nvPr/>
          </p:nvSpPr>
          <p:spPr>
            <a:xfrm>
              <a:off x="116632" y="2144688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188640" y="416091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0688" y="6014215"/>
            <a:ext cx="1397219" cy="139721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09894" y="6037181"/>
            <a:ext cx="1427222" cy="142722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26023" y="7431720"/>
            <a:ext cx="1386547" cy="1386547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33206" y="7554174"/>
            <a:ext cx="1429102" cy="1398588"/>
          </a:xfrm>
          <a:prstGeom prst="rect">
            <a:avLst/>
          </a:prstGeom>
        </p:spPr>
      </p:pic>
      <p:cxnSp>
        <p:nvCxnSpPr>
          <p:cNvPr id="29" name="Straight Arrow Connector 28"/>
          <p:cNvCxnSpPr/>
          <p:nvPr/>
        </p:nvCxnSpPr>
        <p:spPr>
          <a:xfrm>
            <a:off x="1788277" y="4808984"/>
            <a:ext cx="56481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1729416" y="6321152"/>
            <a:ext cx="56481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1699874" y="7689304"/>
            <a:ext cx="56481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9887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7127842"/>
              </p:ext>
            </p:extLst>
          </p:nvPr>
        </p:nvGraphicFramePr>
        <p:xfrm>
          <a:off x="319503" y="630113"/>
          <a:ext cx="2605441" cy="3316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71117" y="430980"/>
            <a:ext cx="181056" cy="446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98764" y="483678"/>
            <a:ext cx="12155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V vs. Untreat</a:t>
            </a:r>
            <a:r>
              <a:rPr lang="en-US" altLang="zh-CN" sz="1200" dirty="0" smtClean="0"/>
              <a:t>ed</a:t>
            </a:r>
            <a:endParaRPr lang="en-US" sz="12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3030120" y="407204"/>
            <a:ext cx="2942958" cy="3497292"/>
            <a:chOff x="3637438" y="268428"/>
            <a:chExt cx="3015008" cy="3335179"/>
          </a:xfrm>
        </p:grpSpPr>
        <p:pic>
          <p:nvPicPr>
            <p:cNvPr id="17" name="Picture 2" descr="E:\RNA-seq EdgeR 41BB\GSEA\my_analysis.Gsea.KEGG LacZ vs untreat\enplot_KEGG_CELL_CYCLE_26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0211" y="497796"/>
              <a:ext cx="2292771" cy="229277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3637438" y="268428"/>
              <a:ext cx="317282" cy="3522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077072" y="2811130"/>
              <a:ext cx="2575374" cy="7924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Enrichment score (ES): 0.6435</a:t>
              </a:r>
            </a:p>
            <a:p>
              <a:r>
                <a:rPr lang="en-US" sz="1200" dirty="0" err="1" smtClean="0"/>
                <a:t>Norminal</a:t>
              </a:r>
              <a:r>
                <a:rPr lang="en-US" sz="1200" dirty="0" smtClean="0"/>
                <a:t> p value:0</a:t>
              </a:r>
            </a:p>
            <a:p>
              <a:r>
                <a:rPr lang="en-US" altLang="zh-CN" sz="1200" dirty="0"/>
                <a:t>False</a:t>
              </a:r>
              <a:r>
                <a:rPr lang="zh-CN" altLang="en-US" sz="1200" dirty="0"/>
                <a:t> </a:t>
              </a:r>
              <a:r>
                <a:rPr lang="en-US" altLang="zh-CN" sz="1200" dirty="0"/>
                <a:t>discovery</a:t>
              </a:r>
              <a:r>
                <a:rPr lang="zh-CN" altLang="en-US" sz="1200" dirty="0"/>
                <a:t> </a:t>
              </a:r>
              <a:r>
                <a:rPr lang="en-US" altLang="zh-CN" sz="1200" dirty="0"/>
                <a:t>rate</a:t>
              </a:r>
              <a:r>
                <a:rPr lang="zh-CN" altLang="en-US" sz="1200" dirty="0"/>
                <a:t> </a:t>
              </a:r>
              <a:r>
                <a:rPr lang="en-US" altLang="zh-CN" sz="1200" dirty="0"/>
                <a:t>(</a:t>
              </a:r>
              <a:r>
                <a:rPr lang="en-US" sz="1200" dirty="0"/>
                <a:t>FDR</a:t>
              </a:r>
              <a:r>
                <a:rPr lang="en-US" altLang="zh-CN" sz="1200" dirty="0"/>
                <a:t>)</a:t>
              </a:r>
              <a:r>
                <a:rPr lang="en-US" sz="1200" dirty="0" smtClean="0"/>
                <a:t> q-value:0.1</a:t>
              </a:r>
            </a:p>
            <a:p>
              <a:endParaRPr lang="en-US" sz="1200" dirty="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548680" y="4592960"/>
            <a:ext cx="5981277" cy="4608512"/>
            <a:chOff x="548680" y="4592960"/>
            <a:chExt cx="5981277" cy="4608512"/>
          </a:xfrm>
        </p:grpSpPr>
        <p:grpSp>
          <p:nvGrpSpPr>
            <p:cNvPr id="20" name="Group 19"/>
            <p:cNvGrpSpPr/>
            <p:nvPr/>
          </p:nvGrpSpPr>
          <p:grpSpPr>
            <a:xfrm>
              <a:off x="548680" y="4592960"/>
              <a:ext cx="4673949" cy="4608512"/>
              <a:chOff x="1268760" y="1928664"/>
              <a:chExt cx="4343260" cy="4194954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8760" y="1928664"/>
                <a:ext cx="3866206" cy="3830930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2110630" y="5754286"/>
                <a:ext cx="21004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 smtClean="0"/>
                  <a:t>P=7.61E-04,</a:t>
                </a:r>
                <a:r>
                  <a:rPr lang="zh-CN" altLang="en-US" dirty="0" smtClean="0"/>
                  <a:t> </a:t>
                </a:r>
                <a:r>
                  <a:rPr lang="en-US" altLang="zh-CN" dirty="0" smtClean="0"/>
                  <a:t>Z=2.372</a:t>
                </a:r>
                <a:endParaRPr lang="en-US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134966" y="5187514"/>
                <a:ext cx="4770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IPA</a:t>
                </a:r>
                <a:endParaRPr lang="en-US" dirty="0"/>
              </a:p>
            </p:txBody>
          </p:sp>
        </p:grp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30327" y="4808984"/>
              <a:ext cx="1799630" cy="2595926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61645" y="48089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8147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836712" y="3094666"/>
            <a:ext cx="5400780" cy="3024336"/>
            <a:chOff x="486390" y="3451865"/>
            <a:chExt cx="4935396" cy="2619751"/>
          </a:xfrm>
        </p:grpSpPr>
        <p:grpSp>
          <p:nvGrpSpPr>
            <p:cNvPr id="14" name="Group 13"/>
            <p:cNvGrpSpPr/>
            <p:nvPr/>
          </p:nvGrpSpPr>
          <p:grpSpPr>
            <a:xfrm>
              <a:off x="486390" y="3461564"/>
              <a:ext cx="4935396" cy="2610052"/>
              <a:chOff x="382216" y="3461564"/>
              <a:chExt cx="4935396" cy="2610052"/>
            </a:xfrm>
          </p:grpSpPr>
          <p:graphicFrame>
            <p:nvGraphicFramePr>
              <p:cNvPr id="16" name="Chart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56967554"/>
                  </p:ext>
                </p:extLst>
              </p:nvPr>
            </p:nvGraphicFramePr>
            <p:xfrm>
              <a:off x="382216" y="3472800"/>
              <a:ext cx="2326704" cy="25603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7" name="Group 16"/>
              <p:cNvGrpSpPr/>
              <p:nvPr/>
            </p:nvGrpSpPr>
            <p:grpSpPr>
              <a:xfrm>
                <a:off x="2995036" y="3461564"/>
                <a:ext cx="2322576" cy="2610052"/>
                <a:chOff x="1835641" y="625887"/>
                <a:chExt cx="3257137" cy="5864354"/>
              </a:xfrm>
            </p:grpSpPr>
            <p:graphicFrame>
              <p:nvGraphicFramePr>
                <p:cNvPr id="18" name="Chart 1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11397526"/>
                    </p:ext>
                  </p:extLst>
                </p:nvPr>
              </p:nvGraphicFramePr>
              <p:xfrm>
                <a:off x="1835641" y="737627"/>
                <a:ext cx="3257137" cy="575261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9" name="TextBox 18"/>
                <p:cNvSpPr txBox="1"/>
                <p:nvPr/>
              </p:nvSpPr>
              <p:spPr>
                <a:xfrm>
                  <a:off x="2444224" y="625887"/>
                  <a:ext cx="13011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SV+</a:t>
                  </a:r>
                  <a:r>
                    <a:rPr lang="el-GR" altLang="zh-CN" sz="1200" dirty="0"/>
                    <a:t> α </a:t>
                  </a:r>
                  <a:r>
                    <a:rPr lang="en-US" sz="1200" dirty="0" smtClean="0"/>
                    <a:t>4</a:t>
                  </a:r>
                  <a:r>
                    <a:rPr lang="en-US" altLang="zh-CN" sz="1200" dirty="0" smtClean="0"/>
                    <a:t>-</a:t>
                  </a:r>
                  <a:r>
                    <a:rPr lang="en-US" sz="1200" dirty="0" smtClean="0"/>
                    <a:t>1BB vs SV</a:t>
                  </a:r>
                  <a:endParaRPr lang="en-US" sz="1200" dirty="0"/>
                </a:p>
              </p:txBody>
            </p:sp>
          </p:grpSp>
        </p:grpSp>
        <p:sp>
          <p:nvSpPr>
            <p:cNvPr id="15" name="TextBox 14"/>
            <p:cNvSpPr txBox="1"/>
            <p:nvPr/>
          </p:nvSpPr>
          <p:spPr>
            <a:xfrm>
              <a:off x="908720" y="3451865"/>
              <a:ext cx="1627883" cy="239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SV+</a:t>
              </a:r>
              <a:r>
                <a:rPr lang="el-GR" altLang="zh-CN" sz="1200" dirty="0"/>
                <a:t> α </a:t>
              </a:r>
              <a:r>
                <a:rPr lang="en-US" sz="1200" dirty="0" smtClean="0"/>
                <a:t>4</a:t>
              </a:r>
              <a:r>
                <a:rPr lang="en-US" altLang="zh-CN" sz="1200" dirty="0" smtClean="0"/>
                <a:t>-</a:t>
              </a:r>
              <a:r>
                <a:rPr lang="en-US" sz="1200" dirty="0" smtClean="0"/>
                <a:t>1BB vs Untreat</a:t>
              </a:r>
              <a:r>
                <a:rPr lang="en-US" altLang="zh-CN" sz="1200" dirty="0" smtClean="0"/>
                <a:t>ed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51069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8996" y="17126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040780" y="170334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56606" y="524103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101666" y="523174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204" y="2000672"/>
            <a:ext cx="2276561" cy="280831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8114" y="2092836"/>
            <a:ext cx="2388634" cy="278815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0480" y="5253120"/>
            <a:ext cx="2310513" cy="2652208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050" y="5353496"/>
            <a:ext cx="2236715" cy="259490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814462" y="7763737"/>
            <a:ext cx="89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28</a:t>
            </a:r>
            <a:r>
              <a:rPr lang="zh-CN" altLang="en-US" dirty="0" smtClean="0"/>
              <a:t> </a:t>
            </a:r>
            <a:r>
              <a:rPr lang="en-US" altLang="zh-CN" dirty="0" smtClean="0"/>
              <a:t>day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5842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700" y="2749550"/>
            <a:ext cx="5562600" cy="4406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79670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99020" y="502500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B</a:t>
            </a:r>
            <a:endParaRPr lang="en-US"/>
          </a:p>
        </p:txBody>
      </p:sp>
      <p:grpSp>
        <p:nvGrpSpPr>
          <p:cNvPr id="7" name="Group 6"/>
          <p:cNvGrpSpPr/>
          <p:nvPr/>
        </p:nvGrpSpPr>
        <p:grpSpPr>
          <a:xfrm>
            <a:off x="548680" y="272480"/>
            <a:ext cx="5626907" cy="4937194"/>
            <a:chOff x="548680" y="272480"/>
            <a:chExt cx="5626907" cy="4937194"/>
          </a:xfrm>
        </p:grpSpPr>
        <p:sp>
          <p:nvSpPr>
            <p:cNvPr id="3" name="TextBox 2"/>
            <p:cNvSpPr txBox="1"/>
            <p:nvPr/>
          </p:nvSpPr>
          <p:spPr>
            <a:xfrm>
              <a:off x="548680" y="27248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mtClean="0"/>
                <a:t>A</a:t>
              </a:r>
              <a:endParaRPr lang="en-US"/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8634" y="641812"/>
              <a:ext cx="5326953" cy="4567862"/>
            </a:xfrm>
            <a:prstGeom prst="rect">
              <a:avLst/>
            </a:prstGeom>
          </p:spPr>
        </p:pic>
      </p:grpSp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354" y="5360804"/>
            <a:ext cx="4826000" cy="364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3131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632" y="416496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348148" y="416496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2989" y="602501"/>
            <a:ext cx="1647589" cy="2009697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920" y="763955"/>
            <a:ext cx="2555938" cy="168679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3461706" y="2742238"/>
            <a:ext cx="1931324" cy="2274252"/>
            <a:chOff x="3461706" y="2742238"/>
            <a:chExt cx="1931324" cy="2274252"/>
          </a:xfrm>
        </p:grpSpPr>
        <p:sp>
          <p:nvSpPr>
            <p:cNvPr id="10" name="TextBox 9"/>
            <p:cNvSpPr txBox="1"/>
            <p:nvPr/>
          </p:nvSpPr>
          <p:spPr>
            <a:xfrm>
              <a:off x="3461706" y="2742238"/>
              <a:ext cx="3113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D</a:t>
              </a: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2989" y="2784242"/>
              <a:ext cx="1830041" cy="2232248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75443" y="4880992"/>
            <a:ext cx="2001429" cy="2360584"/>
            <a:chOff x="188640" y="5097016"/>
            <a:chExt cx="2001429" cy="2360584"/>
          </a:xfrm>
        </p:grpSpPr>
        <p:sp>
          <p:nvSpPr>
            <p:cNvPr id="14" name="TextBox 13"/>
            <p:cNvSpPr txBox="1"/>
            <p:nvPr/>
          </p:nvSpPr>
          <p:spPr>
            <a:xfrm>
              <a:off x="188640" y="5097016"/>
              <a:ext cx="2856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E</a:t>
              </a: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510" y="5279611"/>
              <a:ext cx="1785559" cy="2177989"/>
            </a:xfrm>
            <a:prstGeom prst="rect">
              <a:avLst/>
            </a:prstGeom>
          </p:spPr>
        </p:pic>
      </p:grpSp>
      <p:grpSp>
        <p:nvGrpSpPr>
          <p:cNvPr id="9" name="Group 8"/>
          <p:cNvGrpSpPr/>
          <p:nvPr/>
        </p:nvGrpSpPr>
        <p:grpSpPr>
          <a:xfrm>
            <a:off x="148398" y="2792760"/>
            <a:ext cx="3089275" cy="1921489"/>
            <a:chOff x="148398" y="2742238"/>
            <a:chExt cx="3089275" cy="1921489"/>
          </a:xfrm>
        </p:grpSpPr>
        <p:grpSp>
          <p:nvGrpSpPr>
            <p:cNvPr id="3" name="Group 2"/>
            <p:cNvGrpSpPr/>
            <p:nvPr/>
          </p:nvGrpSpPr>
          <p:grpSpPr>
            <a:xfrm>
              <a:off x="188640" y="2742238"/>
              <a:ext cx="2385148" cy="1921489"/>
              <a:chOff x="188640" y="2742238"/>
              <a:chExt cx="2385148" cy="1921489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88640" y="2742238"/>
                <a:ext cx="29367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C</a:t>
                </a:r>
              </a:p>
            </p:txBody>
          </p:sp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4726" y="2926831"/>
                <a:ext cx="2189062" cy="1736896"/>
              </a:xfrm>
              <a:prstGeom prst="rect">
                <a:avLst/>
              </a:prstGeom>
            </p:spPr>
          </p:pic>
        </p:grp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8398" y="3043372"/>
              <a:ext cx="3089275" cy="16203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22477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770552" y="515112"/>
            <a:ext cx="4386640" cy="4162766"/>
            <a:chOff x="583497" y="515112"/>
            <a:chExt cx="4386640" cy="4162766"/>
          </a:xfrm>
        </p:grpSpPr>
        <p:sp>
          <p:nvSpPr>
            <p:cNvPr id="15" name="TextBox 14"/>
            <p:cNvSpPr txBox="1"/>
            <p:nvPr/>
          </p:nvSpPr>
          <p:spPr>
            <a:xfrm>
              <a:off x="692696" y="515113"/>
              <a:ext cx="8211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Untreat</a:t>
              </a:r>
              <a:r>
                <a:rPr lang="en-US" altLang="zh-CN" sz="1200" dirty="0" smtClean="0"/>
                <a:t>ed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24041" y="515113"/>
              <a:ext cx="3408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S</a:t>
              </a:r>
              <a:r>
                <a:rPr lang="en-US" altLang="zh-CN" sz="1200" smtClean="0"/>
                <a:t>V</a:t>
              </a:r>
              <a:endParaRPr lang="en-US" sz="12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64904" y="515112"/>
              <a:ext cx="12722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/>
                <a:t>SV+</a:t>
              </a:r>
              <a:r>
                <a:rPr lang="en-US" sz="1200" b="1" dirty="0">
                  <a:sym typeface="Symbol" charset="2"/>
                </a:rPr>
                <a:t></a:t>
              </a:r>
              <a:r>
                <a:rPr lang="en-US" sz="1200" dirty="0"/>
                <a:t>4-1BB</a:t>
              </a:r>
              <a:r>
                <a:rPr lang="en-US" sz="1200" b="1" dirty="0"/>
                <a:t> </a:t>
              </a:r>
              <a:r>
                <a:rPr lang="zh-CN" altLang="en-US" sz="1200" dirty="0" smtClean="0"/>
                <a:t> </a:t>
              </a:r>
              <a:r>
                <a:rPr lang="en-US" altLang="zh-CN" sz="1200" dirty="0" smtClean="0"/>
                <a:t>50ug</a:t>
              </a:r>
              <a:endParaRPr lang="en-US" sz="1200" dirty="0"/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1529780" y="800211"/>
              <a:ext cx="1836224" cy="1283184"/>
              <a:chOff x="2513275" y="481263"/>
              <a:chExt cx="2609747" cy="1828800"/>
            </a:xfrm>
          </p:grpSpPr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13275" y="481263"/>
                <a:ext cx="2609747" cy="1828800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56629" y="553455"/>
                <a:ext cx="326869" cy="1756608"/>
              </a:xfrm>
              <a:prstGeom prst="rect">
                <a:avLst/>
              </a:prstGeom>
            </p:spPr>
          </p:pic>
        </p:grp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6952" y="789348"/>
              <a:ext cx="1836224" cy="1283184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3921" y="2159295"/>
              <a:ext cx="1919216" cy="1246944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41072" y="2144095"/>
              <a:ext cx="1929065" cy="1253343"/>
            </a:xfrm>
            <a:prstGeom prst="rect">
              <a:avLst/>
            </a:prstGeom>
          </p:spPr>
        </p:pic>
        <p:grpSp>
          <p:nvGrpSpPr>
            <p:cNvPr id="45" name="Group 44"/>
            <p:cNvGrpSpPr/>
            <p:nvPr/>
          </p:nvGrpSpPr>
          <p:grpSpPr>
            <a:xfrm>
              <a:off x="1518386" y="3492540"/>
              <a:ext cx="3451750" cy="1185338"/>
              <a:chOff x="2022580" y="3266694"/>
              <a:chExt cx="4777725" cy="1828800"/>
            </a:xfrm>
          </p:grpSpPr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2580" y="3266694"/>
                <a:ext cx="2609747" cy="1828800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90558" y="3266694"/>
                <a:ext cx="2609747" cy="1828800"/>
              </a:xfrm>
              <a:prstGeom prst="rect">
                <a:avLst/>
              </a:prstGeom>
            </p:spPr>
          </p:pic>
        </p:grpSp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91795" y="789825"/>
              <a:ext cx="1017102" cy="1277994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83497" y="2154120"/>
              <a:ext cx="1038100" cy="1245343"/>
            </a:xfrm>
            <a:prstGeom prst="rect">
              <a:avLst/>
            </a:prstGeom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98813" y="3485764"/>
              <a:ext cx="1036979" cy="1176538"/>
            </a:xfrm>
            <a:prstGeom prst="rect">
              <a:avLst/>
            </a:prstGeom>
          </p:spPr>
        </p:pic>
      </p:grpSp>
      <p:sp>
        <p:nvSpPr>
          <p:cNvPr id="2" name="TextBox 1"/>
          <p:cNvSpPr txBox="1"/>
          <p:nvPr/>
        </p:nvSpPr>
        <p:spPr>
          <a:xfrm>
            <a:off x="260648" y="3444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mtClean="0"/>
              <a:t>A</a:t>
            </a:r>
            <a:endParaRPr lang="en-US"/>
          </a:p>
        </p:txBody>
      </p:sp>
      <p:grpSp>
        <p:nvGrpSpPr>
          <p:cNvPr id="17" name="Group 16"/>
          <p:cNvGrpSpPr/>
          <p:nvPr/>
        </p:nvGrpSpPr>
        <p:grpSpPr>
          <a:xfrm>
            <a:off x="260648" y="5169024"/>
            <a:ext cx="5575248" cy="2537257"/>
            <a:chOff x="260648" y="5169024"/>
            <a:chExt cx="5575248" cy="2537257"/>
          </a:xfrm>
        </p:grpSpPr>
        <p:sp>
          <p:nvSpPr>
            <p:cNvPr id="3" name="TextBox 2"/>
            <p:cNvSpPr txBox="1"/>
            <p:nvPr/>
          </p:nvSpPr>
          <p:spPr>
            <a:xfrm>
              <a:off x="260648" y="5169024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mtClean="0"/>
                <a:t>B</a:t>
              </a:r>
              <a:endParaRPr lang="en-US"/>
            </a:p>
          </p:txBody>
        </p:sp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918" y="5538356"/>
              <a:ext cx="2774209" cy="2167925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2008" y="5405759"/>
              <a:ext cx="2943888" cy="2300522"/>
            </a:xfrm>
            <a:prstGeom prst="rect">
              <a:avLst/>
            </a:prstGeom>
          </p:spPr>
        </p:pic>
      </p:grpSp>
      <p:pic>
        <p:nvPicPr>
          <p:cNvPr id="39" name="Picture 38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81" y="7832477"/>
            <a:ext cx="2609684" cy="2012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677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1</TotalTime>
  <Words>102</Words>
  <Application>Microsoft Macintosh PowerPoint</Application>
  <PresentationFormat>A4 Paper (210x297 mm)</PresentationFormat>
  <Paragraphs>52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Symbol</vt:lpstr>
      <vt:lpstr>宋体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olumbia University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jun Yu</dc:creator>
  <cp:lastModifiedBy>Microsoft Office User</cp:lastModifiedBy>
  <cp:revision>104</cp:revision>
  <cp:lastPrinted>2019-02-06T16:30:51Z</cp:lastPrinted>
  <dcterms:created xsi:type="dcterms:W3CDTF">2018-11-18T13:21:54Z</dcterms:created>
  <dcterms:modified xsi:type="dcterms:W3CDTF">2019-05-10T21:10:07Z</dcterms:modified>
</cp:coreProperties>
</file>